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7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 varScale="1">
        <p:scale>
          <a:sx n="82" d="100"/>
          <a:sy n="82" d="100"/>
        </p:scale>
        <p:origin x="14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27850" y="735819"/>
            <a:ext cx="31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/>
          <a:srcRect l="13246" r="17353" b="8128"/>
          <a:stretch/>
        </p:blipFill>
        <p:spPr>
          <a:xfrm>
            <a:off x="423973" y="5725423"/>
            <a:ext cx="2789499" cy="2460877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683375" y="735819"/>
            <a:ext cx="5828822" cy="4716753"/>
            <a:chOff x="-55811" y="848597"/>
            <a:chExt cx="9040612" cy="5565047"/>
          </a:xfrm>
        </p:grpSpPr>
        <p:sp>
          <p:nvSpPr>
            <p:cNvPr id="5" name="TextBox 4"/>
            <p:cNvSpPr txBox="1"/>
            <p:nvPr/>
          </p:nvSpPr>
          <p:spPr>
            <a:xfrm>
              <a:off x="-55811" y="977773"/>
              <a:ext cx="1080576" cy="54169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3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6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7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8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2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3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4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05000"/>
                </a:lnSpc>
              </a:pPr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6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43" t="8177" r="26047" b="13703"/>
            <a:stretch/>
          </p:blipFill>
          <p:spPr bwMode="auto">
            <a:xfrm>
              <a:off x="697518" y="848597"/>
              <a:ext cx="8287283" cy="55650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8" name="TextBox 7"/>
          <p:cNvSpPr txBox="1"/>
          <p:nvPr/>
        </p:nvSpPr>
        <p:spPr>
          <a:xfrm>
            <a:off x="427850" y="5586924"/>
            <a:ext cx="315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319121" y="6732387"/>
            <a:ext cx="329002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stribution of the GFP reporter insertion sites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cations of the insertion sites on the yeast chromosomes (grey bars). Some insertion sites fall into special regions, including telomeres (blue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ting loci (r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an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ntromer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green)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ategories of insertion sit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s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their locations relative to the local gene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2054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99</Words>
  <Application>Microsoft Office PowerPoint</Application>
  <PresentationFormat>Letter Paper (8.5x11 in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Manyu Du</cp:lastModifiedBy>
  <cp:revision>283</cp:revision>
  <cp:lastPrinted>2016-12-22T22:05:19Z</cp:lastPrinted>
  <dcterms:created xsi:type="dcterms:W3CDTF">2016-06-14T18:48:14Z</dcterms:created>
  <dcterms:modified xsi:type="dcterms:W3CDTF">2017-04-07T20:52:52Z</dcterms:modified>
</cp:coreProperties>
</file>